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202"/>
    <p:restoredTop sz="94290"/>
  </p:normalViewPr>
  <p:slideViewPr>
    <p:cSldViewPr snapToGrid="0" snapToObjects="1">
      <p:cViewPr varScale="1">
        <p:scale>
          <a:sx n="105" d="100"/>
          <a:sy n="105" d="100"/>
        </p:scale>
        <p:origin x="232" y="19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7C9717-AB99-B946-B107-32E8E739DE06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5D3D0-F649-504F-A0F1-3E7FD9C373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92374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99A3A2-BED4-A545-B8A0-CB0A7E1528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013CDEE-B120-A44D-B3DB-F1FBF2BD73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A7F239-58A4-004B-B745-ED02A09C3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01A56F-AC3E-E141-AA28-321C77F70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54F7E6-97B1-F341-B7F9-CB77F9F59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71109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AF74CF-06B3-DE45-A8BC-46B2EFFA0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259C90A-6B02-ED41-9CE0-BA857579A2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6DE2AC-C80D-2344-BD3E-02BE070E4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97604C-901F-D14A-ADF6-4AA9FEB32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09CCA6-FAC3-394F-AC00-182C2AE87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8408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81D2541-5E90-8B47-8C47-B06127CAF3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EBA732-EB64-3C43-8AC1-DC2AB37C8D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F5CA2D-126E-E347-97FF-0422F37F0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D6EB51-737A-C549-9BC2-7B64254D3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793144-F10C-684E-9533-A4EC19715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38868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6413BE-7028-A647-8895-D2CC9BE40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7782A9-2B23-2743-ACA3-A0B9561449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9972EF-38FD-F549-86D4-0395B01D3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D7A9E9-51D9-404A-87F8-EDFD3D557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73374D-0C25-9E4A-9753-B0C5A4B12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18536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EFA623-05A4-AF46-9A9B-2E28BC76C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15D1D92-90D0-5B47-99BF-4363B289CA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1E7CDA-A9A1-AE40-8C5F-D54834B6F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CDD16C-EDC2-AC4C-B459-DCDF42B54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DE0DDD-4C10-E64E-80BD-B60C16021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17196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66AC58-0AF5-AF48-BA5C-9F1550603A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893103-5FDF-7843-B9A2-7A0C42A34F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3758EE7-08E8-A64D-8352-83557388B6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C002A6-2C52-4945-9307-B969C5236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E42317-F068-3945-905F-91DFE6B39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36E67E-F0B7-2A4B-8345-DAD1077B3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884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E78BAA-AC36-0742-9F4B-CD24D929E0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F3690A-AA5E-F749-B1EC-D8FF153A78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E599895-C8A5-FF47-9C59-5DF5DE5E6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8986D9D-63D2-AD4E-9467-8B54934151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0DC2019-D7CF-9A40-9DB4-F4FB42B6F0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5B5A707-43A5-2E4C-BB4B-097FD4A74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0F05F47-051A-774C-9BC2-AB7DDFE04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FE55467-A101-FB49-91B0-A96A49A37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6480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5BE163-C9D9-F145-9B41-42183A711F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ABA1731-CDB2-004D-8BFD-388D06E6D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E883E4F-6617-F549-A5BB-E9B803E25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07A5FB9-6231-824B-A69F-3A7087678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14349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796AE03-6BBF-3B4C-A56F-6E17EF6C4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686C3E1-06D6-184E-9167-D5D7AF40B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5F5B067-792A-434E-ADDD-72F48974D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0980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C733CD-6E73-EC40-BD78-182EA04A00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ED9DDD-740F-074E-935C-C743F911EE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9BB77D8-4DCF-A447-A264-5B90EB8110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E571F98-4562-664A-A16F-37E60FD78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46E9A8D-EE94-2642-AE60-5859AB65A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B17968-6642-664F-9EE4-05A717571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62489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4924B8-1CB3-0C41-8F7B-A8D7DE98A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5A36400-8A6D-DF4C-8BB1-F9DA67AFC5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BBFC04B-DF0C-804F-86CB-711EE1A593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8F058C-A44B-DE40-8FCD-8DF1CB5E5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3A42BA-8397-1D4C-B0BA-0AF14E90D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47B06D-E4CF-9048-9E9C-885E9101B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24261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4A79A0E-08C0-CA43-997A-45767C625A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E3897E1-2A47-FC40-B24E-492C2A0BA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3C4F0-28B5-9045-B081-54A48B1ADA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41C51-5A16-FB47-8861-34736C0AA973}" type="datetimeFigureOut">
              <a:rPr kumimoji="1" lang="zh-CN" altLang="en-US" smtClean="0"/>
              <a:t>2020/5/15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095D82-9DC2-A849-A95D-FF2AFA5F0D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73F656-0356-CC47-8C79-86131879A9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D4954-4F21-7D44-97D8-EC4ABADB7F6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43415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E6C4695-9144-0549-A2B7-22614C9A9692}"/>
              </a:ext>
            </a:extLst>
          </p:cNvPr>
          <p:cNvSpPr txBox="1"/>
          <p:nvPr/>
        </p:nvSpPr>
        <p:spPr>
          <a:xfrm>
            <a:off x="3337352" y="47929"/>
            <a:ext cx="4992432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Oral examination, blood test, X-ray (Day 0)</a:t>
            </a:r>
          </a:p>
          <a:p>
            <a:endParaRPr lang="en-US" sz="1400" b="1" dirty="0"/>
          </a:p>
          <a:p>
            <a:r>
              <a:rPr lang="en-US" sz="1400" b="1" dirty="0"/>
              <a:t>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3EAFF2-7A3C-1A43-9C49-20CA5A18B459}"/>
              </a:ext>
            </a:extLst>
          </p:cNvPr>
          <p:cNvSpPr txBox="1"/>
          <p:nvPr/>
        </p:nvSpPr>
        <p:spPr>
          <a:xfrm>
            <a:off x="5032742" y="2038603"/>
            <a:ext cx="2517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&amp;E (Day 37)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3C4D32-B169-DE43-AF82-15C248B3BF6A}"/>
              </a:ext>
            </a:extLst>
          </p:cNvPr>
          <p:cNvSpPr txBox="1"/>
          <p:nvPr/>
        </p:nvSpPr>
        <p:spPr>
          <a:xfrm>
            <a:off x="5080804" y="2708218"/>
            <a:ext cx="15055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HC (</a:t>
            </a:r>
            <a:r>
              <a:rPr lang="en-US" b="1"/>
              <a:t>Day 44)</a:t>
            </a:r>
            <a:endParaRPr lang="en-US" b="1" dirty="0"/>
          </a:p>
          <a:p>
            <a:endParaRPr lang="en-US" sz="1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2C9904-F1DE-764C-B2C0-37B86946EE21}"/>
              </a:ext>
            </a:extLst>
          </p:cNvPr>
          <p:cNvSpPr txBox="1"/>
          <p:nvPr/>
        </p:nvSpPr>
        <p:spPr>
          <a:xfrm>
            <a:off x="4094921" y="1368988"/>
            <a:ext cx="3267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IgG4 concentration (Day  30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401ACE8-C738-E145-A468-4C655953AC3C}"/>
              </a:ext>
            </a:extLst>
          </p:cNvPr>
          <p:cNvSpPr txBox="1"/>
          <p:nvPr/>
        </p:nvSpPr>
        <p:spPr>
          <a:xfrm>
            <a:off x="5988936" y="3117608"/>
            <a:ext cx="11948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220FA54-72D1-B44F-9DD4-4B408E8B4E87}"/>
              </a:ext>
            </a:extLst>
          </p:cNvPr>
          <p:cNvSpPr txBox="1"/>
          <p:nvPr/>
        </p:nvSpPr>
        <p:spPr>
          <a:xfrm>
            <a:off x="4750292" y="4083012"/>
            <a:ext cx="2166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iagnosis (Day 60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DD9B39F-F9BD-7B4A-AFD4-59377397FCC6}"/>
              </a:ext>
            </a:extLst>
          </p:cNvPr>
          <p:cNvSpPr txBox="1"/>
          <p:nvPr/>
        </p:nvSpPr>
        <p:spPr>
          <a:xfrm>
            <a:off x="3502757" y="4821676"/>
            <a:ext cx="5564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orticosteroids and periodontal therapy (Day 66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8C8BE2B-6AA3-8545-A9BE-0AC5B6DE927C}"/>
              </a:ext>
            </a:extLst>
          </p:cNvPr>
          <p:cNvSpPr txBox="1"/>
          <p:nvPr/>
        </p:nvSpPr>
        <p:spPr>
          <a:xfrm>
            <a:off x="2990283" y="5560340"/>
            <a:ext cx="6077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lieved gingival swelling without recurrence (Day 180)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2FF140F-727C-8E47-A47F-1678EE7FFB03}"/>
              </a:ext>
            </a:extLst>
          </p:cNvPr>
          <p:cNvSpPr txBox="1"/>
          <p:nvPr/>
        </p:nvSpPr>
        <p:spPr>
          <a:xfrm>
            <a:off x="4260024" y="721731"/>
            <a:ext cx="3232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one marrow test (Day 5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E4634B3-BE54-E54C-A123-A4DEE13CE93E}"/>
              </a:ext>
            </a:extLst>
          </p:cNvPr>
          <p:cNvSpPr txBox="1"/>
          <p:nvPr/>
        </p:nvSpPr>
        <p:spPr>
          <a:xfrm>
            <a:off x="4887637" y="3436258"/>
            <a:ext cx="1891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ET-CT (Day 50)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70F1B168-3ED6-614D-910E-CF6947C0B3D7}"/>
              </a:ext>
            </a:extLst>
          </p:cNvPr>
          <p:cNvCxnSpPr>
            <a:cxnSpLocks/>
          </p:cNvCxnSpPr>
          <p:nvPr/>
        </p:nvCxnSpPr>
        <p:spPr>
          <a:xfrm>
            <a:off x="5406156" y="5228823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0A567C0C-50E9-6040-B166-2B9CD1B0E115}"/>
              </a:ext>
            </a:extLst>
          </p:cNvPr>
          <p:cNvCxnSpPr>
            <a:cxnSpLocks/>
          </p:cNvCxnSpPr>
          <p:nvPr/>
        </p:nvCxnSpPr>
        <p:spPr>
          <a:xfrm>
            <a:off x="5406156" y="4526956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CF2E6CFE-C075-234C-A51A-E01756A50B3A}"/>
              </a:ext>
            </a:extLst>
          </p:cNvPr>
          <p:cNvCxnSpPr>
            <a:cxnSpLocks/>
          </p:cNvCxnSpPr>
          <p:nvPr/>
        </p:nvCxnSpPr>
        <p:spPr>
          <a:xfrm>
            <a:off x="5406156" y="3788292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7616558F-AAE5-C14A-A19A-F5EF3EE58E9A}"/>
              </a:ext>
            </a:extLst>
          </p:cNvPr>
          <p:cNvCxnSpPr>
            <a:cxnSpLocks/>
          </p:cNvCxnSpPr>
          <p:nvPr/>
        </p:nvCxnSpPr>
        <p:spPr>
          <a:xfrm>
            <a:off x="5401039" y="3141538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ADD55DE6-B360-F545-B4E6-DE79FE8C0395}"/>
              </a:ext>
            </a:extLst>
          </p:cNvPr>
          <p:cNvCxnSpPr>
            <a:cxnSpLocks/>
          </p:cNvCxnSpPr>
          <p:nvPr/>
        </p:nvCxnSpPr>
        <p:spPr>
          <a:xfrm>
            <a:off x="5401039" y="2440146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B41A32FE-5E80-ED4E-8C2D-EC1A8AF2316D}"/>
              </a:ext>
            </a:extLst>
          </p:cNvPr>
          <p:cNvCxnSpPr>
            <a:cxnSpLocks/>
          </p:cNvCxnSpPr>
          <p:nvPr/>
        </p:nvCxnSpPr>
        <p:spPr>
          <a:xfrm>
            <a:off x="5401039" y="1779458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9A982025-E0B6-3E4B-B34F-5BE468AAA011}"/>
              </a:ext>
            </a:extLst>
          </p:cNvPr>
          <p:cNvCxnSpPr>
            <a:cxnSpLocks/>
          </p:cNvCxnSpPr>
          <p:nvPr/>
        </p:nvCxnSpPr>
        <p:spPr>
          <a:xfrm>
            <a:off x="5395922" y="1109970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426773DA-C1B2-C34E-8508-8FDE0D557B15}"/>
              </a:ext>
            </a:extLst>
          </p:cNvPr>
          <p:cNvCxnSpPr>
            <a:cxnSpLocks/>
          </p:cNvCxnSpPr>
          <p:nvPr/>
        </p:nvCxnSpPr>
        <p:spPr>
          <a:xfrm>
            <a:off x="5390805" y="460976"/>
            <a:ext cx="0" cy="294720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E4380500-02F2-814D-9E37-FFCBAAB2A17E}"/>
              </a:ext>
            </a:extLst>
          </p:cNvPr>
          <p:cNvSpPr/>
          <p:nvPr/>
        </p:nvSpPr>
        <p:spPr>
          <a:xfrm>
            <a:off x="2425570" y="6339062"/>
            <a:ext cx="1338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zh-CN" altLang="en-US" b="1" dirty="0"/>
              <a:t>               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1138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91</TotalTime>
  <Words>67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张 尽美</cp:lastModifiedBy>
  <cp:revision>384</cp:revision>
  <cp:lastPrinted>2020-02-10T01:02:47Z</cp:lastPrinted>
  <dcterms:created xsi:type="dcterms:W3CDTF">2019-03-27T00:53:44Z</dcterms:created>
  <dcterms:modified xsi:type="dcterms:W3CDTF">2020-05-15T17:23:31Z</dcterms:modified>
</cp:coreProperties>
</file>